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2" d="100"/>
          <a:sy n="102" d="100"/>
        </p:scale>
        <p:origin x="8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8449A84-9BD3-B7D8-8695-4E4901E6100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B177AED-7C54-592D-7D0A-47DC45682B5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E034F8F-1509-8ECC-8163-37F50E1F1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29BB9-D42F-4EEB-BFDC-CAC9FBC33380}" type="datetimeFigureOut">
              <a:rPr lang="zh-CN" altLang="en-US" smtClean="0"/>
              <a:t>2023/9/14/Thu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25142F6-68E0-2B41-9365-4462B7AFE8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AAA40E3-E9C9-6846-AD31-764606D39D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4F10C-BC52-4A73-802A-5ED2919DA1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161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5F0C97-F39E-9330-EE0F-13E376E305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7214D52-AB3F-04B9-2167-5167210A36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CEC4DDF-93B2-7780-B875-26F69F4418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29BB9-D42F-4EEB-BFDC-CAC9FBC33380}" type="datetimeFigureOut">
              <a:rPr lang="zh-CN" altLang="en-US" smtClean="0"/>
              <a:t>2023/9/14/Thu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970FBEA-53D6-D833-6B51-D2A0A0BCF3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EDEAC83-3FFB-ACEA-5DFB-C1211DCEA7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4F10C-BC52-4A73-802A-5ED2919DA1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23089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20424B2-58C7-C0B9-204C-C6524A0817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4839D54-BF9C-74BE-EB48-A6FE40A486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5F5A220-D991-E48F-502A-D3A12C6FBE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29BB9-D42F-4EEB-BFDC-CAC9FBC33380}" type="datetimeFigureOut">
              <a:rPr lang="zh-CN" altLang="en-US" smtClean="0"/>
              <a:t>2023/9/14/Thu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19E742E-94C1-6772-61D8-ACDBAB9043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5332087-44CE-0C27-2E5C-1DC2CC631D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4F10C-BC52-4A73-802A-5ED2919DA1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7410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AA5F0E0-94AA-9084-751E-388151AD26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81C61BE-B57B-3598-1C3B-803CF9286D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77CD8C-9D85-0F48-0C90-27E5BA7180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29BB9-D42F-4EEB-BFDC-CAC9FBC33380}" type="datetimeFigureOut">
              <a:rPr lang="zh-CN" altLang="en-US" smtClean="0"/>
              <a:t>2023/9/14/Thu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679CE43-130D-E299-5FAC-21614F1E7D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17DFFD9-669A-3F4F-934A-DD6ACF503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4F10C-BC52-4A73-802A-5ED2919DA1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71418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3513ED2-7FD2-539E-21B4-9869ABC1FA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7712CBB-2FB6-3CBA-3179-417C68A045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783208C-6DD3-A3D6-CE24-AFCC318885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29BB9-D42F-4EEB-BFDC-CAC9FBC33380}" type="datetimeFigureOut">
              <a:rPr lang="zh-CN" altLang="en-US" smtClean="0"/>
              <a:t>2023/9/14/Thu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21A2D0D-D6AD-4C38-A970-797CB2650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F8AED3C-7730-EEEE-8B11-0AC3D06042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4F10C-BC52-4A73-802A-5ED2919DA1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10948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A885ED-4F77-0687-E281-C78AA4620D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1BA3CE9-5957-0CC4-EAA9-84032273184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6005BF5-4DB4-D736-6E2E-0E32771065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28B0680-4151-0A4B-F294-2450985ACC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29BB9-D42F-4EEB-BFDC-CAC9FBC33380}" type="datetimeFigureOut">
              <a:rPr lang="zh-CN" altLang="en-US" smtClean="0"/>
              <a:t>2023/9/14/Thu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4421135-401C-7B95-2681-7F659A76C5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CB0A3C3-39B2-E2BD-17CB-F1A3AB56F6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4F10C-BC52-4A73-802A-5ED2919DA1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24048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534BD30-82C3-BC48-6ED5-5FB8D69C82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F6073F9-B9A5-5654-94E5-826C334C22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EFE6BA3-3BC7-466C-49FA-672DBB140E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77EBED6-EF71-910C-F6DD-7BD40A1714C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46FDAC7-CAD7-F2C6-1BAC-003231D97F0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9BA016D-228F-44DE-73A8-165550F344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29BB9-D42F-4EEB-BFDC-CAC9FBC33380}" type="datetimeFigureOut">
              <a:rPr lang="zh-CN" altLang="en-US" smtClean="0"/>
              <a:t>2023/9/14/Thu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2DE98E4-41ED-73F3-9179-50C5FBF924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AC6FB38-40D6-C3CF-33F8-82FEF3BC82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4F10C-BC52-4A73-802A-5ED2919DA1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8914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CC3D5D-CC1C-2AF2-CD9D-52703093D3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A7DE583-6F1E-6CC2-BF76-A75D14C444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29BB9-D42F-4EEB-BFDC-CAC9FBC33380}" type="datetimeFigureOut">
              <a:rPr lang="zh-CN" altLang="en-US" smtClean="0"/>
              <a:t>2023/9/14/Thu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7C168B1-0F24-9A99-3A17-B7F8AAF1BC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8337E05-770B-3CF4-FE28-8E5A28B7E7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4F10C-BC52-4A73-802A-5ED2919DA1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07148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839EC61-F497-66B9-D982-B51AB4643D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29BB9-D42F-4EEB-BFDC-CAC9FBC33380}" type="datetimeFigureOut">
              <a:rPr lang="zh-CN" altLang="en-US" smtClean="0"/>
              <a:t>2023/9/14/Thu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C40DF45-7034-24C0-F500-1E09413D57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377D265-4822-A9FB-170E-969A283BEC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4F10C-BC52-4A73-802A-5ED2919DA1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08568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74A450-7BCD-2EA7-4A05-287B81713F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3E5D53E-9267-D142-9080-8EB40454CBB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54036E2-A433-4316-FE5A-419F20C207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E80597F-B59C-B834-DCCA-644E63600F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29BB9-D42F-4EEB-BFDC-CAC9FBC33380}" type="datetimeFigureOut">
              <a:rPr lang="zh-CN" altLang="en-US" smtClean="0"/>
              <a:t>2023/9/14/Thu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8D93D66-E98B-528C-853B-CDC2825313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5E05403-7340-0281-43A1-AA0425504B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4F10C-BC52-4A73-802A-5ED2919DA1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49098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0146C9-12D0-D151-E489-05183142D4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146CAF2-F06C-7717-A957-DFF87139E92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2CFAE05-EF00-C561-374C-4DCE596B02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CA4ACCF-EE0C-6240-4FB6-B2F775D4F6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29BB9-D42F-4EEB-BFDC-CAC9FBC33380}" type="datetimeFigureOut">
              <a:rPr lang="zh-CN" altLang="en-US" smtClean="0"/>
              <a:t>2023/9/14/Thu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EBE45B7-FFB1-CC63-1CDA-FC3261499B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92036BC-7E4B-47F4-8637-0A970D9AD5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4F10C-BC52-4A73-802A-5ED2919DA1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3039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E4BAF2F-4A39-EDD5-30B9-B26728BC97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C870422-EF39-136E-6877-177AFD89ED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0556225-70FE-240F-573A-009E1554E2B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629BB9-D42F-4EEB-BFDC-CAC9FBC33380}" type="datetimeFigureOut">
              <a:rPr lang="zh-CN" altLang="en-US" smtClean="0"/>
              <a:t>2023/9/14/Thu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5097E5E-1D6B-ECA5-A3E2-87DD0D4C3E6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D59299A-0B0A-5959-7BD1-3163736705F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C4F10C-BC52-4A73-802A-5ED2919DA1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5567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DD89D56C-4A81-AFE4-F3CD-886703148A3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57" t="34658" r="14573" b="21972"/>
          <a:stretch/>
        </p:blipFill>
        <p:spPr bwMode="auto">
          <a:xfrm flipV="1">
            <a:off x="2564923" y="445619"/>
            <a:ext cx="6550324" cy="2983381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E816A4F1-9170-5F32-208E-FF9E6E329DA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26" t="43675" r="13020" b="20549"/>
          <a:stretch/>
        </p:blipFill>
        <p:spPr bwMode="auto">
          <a:xfrm flipV="1">
            <a:off x="2564923" y="3026319"/>
            <a:ext cx="6504316" cy="255784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7" name="文本框 2">
            <a:extLst>
              <a:ext uri="{FF2B5EF4-FFF2-40B4-BE49-F238E27FC236}">
                <a16:creationId xmlns:a16="http://schemas.microsoft.com/office/drawing/2014/main" id="{DD6D8BE8-9CFA-BAB0-20CD-A68166F35A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90938" y="811636"/>
            <a:ext cx="1832822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arker:</a:t>
            </a:r>
          </a:p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4-120kDa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" name="文本框 2">
            <a:extLst>
              <a:ext uri="{FF2B5EF4-FFF2-40B4-BE49-F238E27FC236}">
                <a16:creationId xmlns:a16="http://schemas.microsoft.com/office/drawing/2014/main" id="{185B1A15-647B-93E8-4719-962591B84E5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03391" y="4236898"/>
            <a:ext cx="841345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4kDa</a:t>
            </a:r>
            <a:endParaRPr lang="zh-CN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文本框 2">
            <a:extLst>
              <a:ext uri="{FF2B5EF4-FFF2-40B4-BE49-F238E27FC236}">
                <a16:creationId xmlns:a16="http://schemas.microsoft.com/office/drawing/2014/main" id="{DE3647BA-3804-C674-C42C-1DE7C0C7A0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56500" y="3543611"/>
            <a:ext cx="963302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25kDa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1" name="文本框 2">
            <a:extLst>
              <a:ext uri="{FF2B5EF4-FFF2-40B4-BE49-F238E27FC236}">
                <a16:creationId xmlns:a16="http://schemas.microsoft.com/office/drawing/2014/main" id="{BA21BD5F-01EC-9234-3C54-9A7356810B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77191" y="3110163"/>
            <a:ext cx="839614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30kDa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2" name="文本框 2">
            <a:extLst>
              <a:ext uri="{FF2B5EF4-FFF2-40B4-BE49-F238E27FC236}">
                <a16:creationId xmlns:a16="http://schemas.microsoft.com/office/drawing/2014/main" id="{52F65F5D-24C0-A08F-B06B-25C4D5E981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35764" y="1584442"/>
            <a:ext cx="881039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0kDa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" name="文本框 2">
            <a:extLst>
              <a:ext uri="{FF2B5EF4-FFF2-40B4-BE49-F238E27FC236}">
                <a16:creationId xmlns:a16="http://schemas.microsoft.com/office/drawing/2014/main" id="{073FFDC5-2B08-3AD9-0BF8-3A854A8507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03391" y="2253513"/>
            <a:ext cx="881039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50kDa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" name="文本框 2">
            <a:extLst>
              <a:ext uri="{FF2B5EF4-FFF2-40B4-BE49-F238E27FC236}">
                <a16:creationId xmlns:a16="http://schemas.microsoft.com/office/drawing/2014/main" id="{5872BB9E-A446-3FBA-A378-1D89000AC85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06829" y="2011236"/>
            <a:ext cx="881039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70kDa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5" name="文本框 2">
            <a:extLst>
              <a:ext uri="{FF2B5EF4-FFF2-40B4-BE49-F238E27FC236}">
                <a16:creationId xmlns:a16="http://schemas.microsoft.com/office/drawing/2014/main" id="{D8083B90-5689-89E1-47FB-3265842FE1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83543" y="2756214"/>
            <a:ext cx="881039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40kDa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6" name="文本框 2">
            <a:extLst>
              <a:ext uri="{FF2B5EF4-FFF2-40B4-BE49-F238E27FC236}">
                <a16:creationId xmlns:a16="http://schemas.microsoft.com/office/drawing/2014/main" id="{3B6DB8BA-4F50-A135-B133-6D8D4AF83A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35765" y="1376946"/>
            <a:ext cx="881039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20kDa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7" name="文本框 2">
            <a:extLst>
              <a:ext uri="{FF2B5EF4-FFF2-40B4-BE49-F238E27FC236}">
                <a16:creationId xmlns:a16="http://schemas.microsoft.com/office/drawing/2014/main" id="{E3CAF0A9-34C0-7914-4DD4-1ED442B8ADB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92805" y="2177606"/>
            <a:ext cx="1018924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β-ACTIN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8" name="文本框 2">
            <a:extLst>
              <a:ext uri="{FF2B5EF4-FFF2-40B4-BE49-F238E27FC236}">
                <a16:creationId xmlns:a16="http://schemas.microsoft.com/office/drawing/2014/main" id="{3F65254A-F5D6-B3BA-899F-2AF5BBF055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72815" y="3756240"/>
            <a:ext cx="1018924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MV CP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AA14ACAB-CD4C-5C56-2EA3-CB79D2EA414B}"/>
              </a:ext>
            </a:extLst>
          </p:cNvPr>
          <p:cNvSpPr/>
          <p:nvPr/>
        </p:nvSpPr>
        <p:spPr>
          <a:xfrm>
            <a:off x="6400800" y="1443487"/>
            <a:ext cx="1623939" cy="2793411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文本框 2">
            <a:extLst>
              <a:ext uri="{FF2B5EF4-FFF2-40B4-BE49-F238E27FC236}">
                <a16:creationId xmlns:a16="http://schemas.microsoft.com/office/drawing/2014/main" id="{94C42967-1E0F-509C-AFBE-EC1A78CA36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00798" y="1535229"/>
            <a:ext cx="1018924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L-2</a:t>
            </a:r>
            <a:r>
              <a:rPr lang="en-US" altLang="zh-CN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pi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1" name="文本框 2">
            <a:extLst>
              <a:ext uri="{FF2B5EF4-FFF2-40B4-BE49-F238E27FC236}">
                <a16:creationId xmlns:a16="http://schemas.microsoft.com/office/drawing/2014/main" id="{3689EC05-A000-ED00-37C2-84B7C971B9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34973" y="1537227"/>
            <a:ext cx="1018924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L-7</a:t>
            </a:r>
            <a:r>
              <a:rPr lang="en-US" altLang="zh-CN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pi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EFD8B703-7F9E-420B-7049-CBCFCAAB1710}"/>
              </a:ext>
            </a:extLst>
          </p:cNvPr>
          <p:cNvCxnSpPr/>
          <p:nvPr/>
        </p:nvCxnSpPr>
        <p:spPr>
          <a:xfrm>
            <a:off x="6521570" y="1917182"/>
            <a:ext cx="613403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C6E598B3-B138-40AA-0C6D-40A2DB63C1E3}"/>
              </a:ext>
            </a:extLst>
          </p:cNvPr>
          <p:cNvCxnSpPr/>
          <p:nvPr/>
        </p:nvCxnSpPr>
        <p:spPr>
          <a:xfrm>
            <a:off x="7212769" y="1913548"/>
            <a:ext cx="613403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">
            <a:extLst>
              <a:ext uri="{FF2B5EF4-FFF2-40B4-BE49-F238E27FC236}">
                <a16:creationId xmlns:a16="http://schemas.microsoft.com/office/drawing/2014/main" id="{32EF12D7-EB35-0DA6-E28E-3A4943F92B93}"/>
              </a:ext>
            </a:extLst>
          </p:cNvPr>
          <p:cNvSpPr txBox="1">
            <a:spLocks noChangeArrowheads="1"/>
          </p:cNvSpPr>
          <p:nvPr/>
        </p:nvSpPr>
        <p:spPr bwMode="auto">
          <a:xfrm rot="18862301">
            <a:off x="6423157" y="1808116"/>
            <a:ext cx="899160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2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326</a:t>
            </a:r>
            <a:endParaRPr 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6" name="文本框 2">
            <a:extLst>
              <a:ext uri="{FF2B5EF4-FFF2-40B4-BE49-F238E27FC236}">
                <a16:creationId xmlns:a16="http://schemas.microsoft.com/office/drawing/2014/main" id="{20C8C0BD-853A-F939-C4BA-B2A318E59B44}"/>
              </a:ext>
            </a:extLst>
          </p:cNvPr>
          <p:cNvSpPr txBox="1">
            <a:spLocks noChangeArrowheads="1"/>
          </p:cNvSpPr>
          <p:nvPr/>
        </p:nvSpPr>
        <p:spPr bwMode="auto">
          <a:xfrm rot="18862301">
            <a:off x="6763188" y="1835641"/>
            <a:ext cx="899160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altLang="zh-CN" sz="1200" kern="100" dirty="0">
                <a:solidFill>
                  <a:srgbClr val="FF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JT88</a:t>
            </a:r>
            <a:endParaRPr 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7" name="文本框 2">
            <a:extLst>
              <a:ext uri="{FF2B5EF4-FFF2-40B4-BE49-F238E27FC236}">
                <a16:creationId xmlns:a16="http://schemas.microsoft.com/office/drawing/2014/main" id="{199DA1F8-B207-7E51-1491-D5D6D49BEB84}"/>
              </a:ext>
            </a:extLst>
          </p:cNvPr>
          <p:cNvSpPr txBox="1">
            <a:spLocks noChangeArrowheads="1"/>
          </p:cNvSpPr>
          <p:nvPr/>
        </p:nvSpPr>
        <p:spPr bwMode="auto">
          <a:xfrm rot="18862301">
            <a:off x="7117173" y="1822462"/>
            <a:ext cx="899160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2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326</a:t>
            </a:r>
            <a:endParaRPr 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8" name="文本框 2">
            <a:extLst>
              <a:ext uri="{FF2B5EF4-FFF2-40B4-BE49-F238E27FC236}">
                <a16:creationId xmlns:a16="http://schemas.microsoft.com/office/drawing/2014/main" id="{1E1B54CB-D4E0-3AB9-9E46-B193D59C4FBF}"/>
              </a:ext>
            </a:extLst>
          </p:cNvPr>
          <p:cNvSpPr txBox="1">
            <a:spLocks noChangeArrowheads="1"/>
          </p:cNvSpPr>
          <p:nvPr/>
        </p:nvSpPr>
        <p:spPr bwMode="auto">
          <a:xfrm rot="18862301">
            <a:off x="7515348" y="1821738"/>
            <a:ext cx="899160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altLang="zh-CN" sz="1200" kern="100" dirty="0">
                <a:solidFill>
                  <a:srgbClr val="FF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JT88</a:t>
            </a:r>
            <a:endParaRPr 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9" name="文本框 2">
            <a:extLst>
              <a:ext uri="{FF2B5EF4-FFF2-40B4-BE49-F238E27FC236}">
                <a16:creationId xmlns:a16="http://schemas.microsoft.com/office/drawing/2014/main" id="{623569F1-B6DB-D64A-C69B-D53370631B20}"/>
              </a:ext>
            </a:extLst>
          </p:cNvPr>
          <p:cNvSpPr txBox="1">
            <a:spLocks noChangeArrowheads="1"/>
          </p:cNvSpPr>
          <p:nvPr/>
        </p:nvSpPr>
        <p:spPr bwMode="auto">
          <a:xfrm rot="18862301">
            <a:off x="6399436" y="3295564"/>
            <a:ext cx="899160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2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326</a:t>
            </a:r>
            <a:endParaRPr 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0" name="文本框 2">
            <a:extLst>
              <a:ext uri="{FF2B5EF4-FFF2-40B4-BE49-F238E27FC236}">
                <a16:creationId xmlns:a16="http://schemas.microsoft.com/office/drawing/2014/main" id="{F9C5109E-66B9-1D40-7C47-73F5B8113568}"/>
              </a:ext>
            </a:extLst>
          </p:cNvPr>
          <p:cNvSpPr txBox="1">
            <a:spLocks noChangeArrowheads="1"/>
          </p:cNvSpPr>
          <p:nvPr/>
        </p:nvSpPr>
        <p:spPr bwMode="auto">
          <a:xfrm rot="18862301">
            <a:off x="6785815" y="3325001"/>
            <a:ext cx="899160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altLang="zh-CN" sz="1200" kern="100" dirty="0">
                <a:solidFill>
                  <a:srgbClr val="FF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JT88</a:t>
            </a:r>
            <a:endParaRPr 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1" name="文本框 2">
            <a:extLst>
              <a:ext uri="{FF2B5EF4-FFF2-40B4-BE49-F238E27FC236}">
                <a16:creationId xmlns:a16="http://schemas.microsoft.com/office/drawing/2014/main" id="{757791DB-D0E5-EB73-A7FA-F25D49A67CFC}"/>
              </a:ext>
            </a:extLst>
          </p:cNvPr>
          <p:cNvSpPr txBox="1">
            <a:spLocks noChangeArrowheads="1"/>
          </p:cNvSpPr>
          <p:nvPr/>
        </p:nvSpPr>
        <p:spPr bwMode="auto">
          <a:xfrm rot="18862301">
            <a:off x="7155075" y="3331884"/>
            <a:ext cx="899160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2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326</a:t>
            </a:r>
            <a:endParaRPr 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2" name="文本框 2">
            <a:extLst>
              <a:ext uri="{FF2B5EF4-FFF2-40B4-BE49-F238E27FC236}">
                <a16:creationId xmlns:a16="http://schemas.microsoft.com/office/drawing/2014/main" id="{B711ED30-85EA-1CDF-C0C4-8BCFCA0834FF}"/>
              </a:ext>
            </a:extLst>
          </p:cNvPr>
          <p:cNvSpPr txBox="1">
            <a:spLocks noChangeArrowheads="1"/>
          </p:cNvSpPr>
          <p:nvPr/>
        </p:nvSpPr>
        <p:spPr bwMode="auto">
          <a:xfrm rot="18862301">
            <a:off x="7527465" y="3347620"/>
            <a:ext cx="899160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altLang="zh-CN" sz="1200" kern="100" dirty="0">
                <a:solidFill>
                  <a:srgbClr val="FF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JT88</a:t>
            </a:r>
            <a:endParaRPr 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03623F34-6643-93E7-EEEB-82C23BA1ABFD}"/>
              </a:ext>
            </a:extLst>
          </p:cNvPr>
          <p:cNvSpPr txBox="1"/>
          <p:nvPr/>
        </p:nvSpPr>
        <p:spPr>
          <a:xfrm>
            <a:off x="1702278" y="5669025"/>
            <a:ext cx="7758023" cy="6771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762000" algn="ctr"/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lang="en-US" altLang="zh-CN" sz="20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1d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: The original figure of WB analysis (IL). The purpose bands were highlighted in red frame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08063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BE154999-813A-3856-53E5-883A485C4F0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04" t="38623" r="16735" b="16176"/>
          <a:stretch/>
        </p:blipFill>
        <p:spPr bwMode="auto">
          <a:xfrm flipV="1">
            <a:off x="2913640" y="730364"/>
            <a:ext cx="5482737" cy="2045267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8C2735E9-0F14-2EB6-DE86-0E86534D529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86" t="25506" r="15901" b="39444"/>
          <a:stretch/>
        </p:blipFill>
        <p:spPr bwMode="auto">
          <a:xfrm>
            <a:off x="2913640" y="2553418"/>
            <a:ext cx="5402226" cy="214389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文本框 2">
            <a:extLst>
              <a:ext uri="{FF2B5EF4-FFF2-40B4-BE49-F238E27FC236}">
                <a16:creationId xmlns:a16="http://schemas.microsoft.com/office/drawing/2014/main" id="{C81E3878-17D0-C364-BF82-3E038D9125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33129" y="3684808"/>
            <a:ext cx="841345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4kDa</a:t>
            </a:r>
            <a:endParaRPr lang="zh-CN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文本框 2">
            <a:extLst>
              <a:ext uri="{FF2B5EF4-FFF2-40B4-BE49-F238E27FC236}">
                <a16:creationId xmlns:a16="http://schemas.microsoft.com/office/drawing/2014/main" id="{03E77FE7-C1FE-2311-6E4E-0160E7BE92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33129" y="3096260"/>
            <a:ext cx="963302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25kDa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2" name="文本框 2">
            <a:extLst>
              <a:ext uri="{FF2B5EF4-FFF2-40B4-BE49-F238E27FC236}">
                <a16:creationId xmlns:a16="http://schemas.microsoft.com/office/drawing/2014/main" id="{9EDE94AB-258A-76FB-DB05-2326855285C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34860" y="2737165"/>
            <a:ext cx="839614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30kDa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3" name="文本框 2">
            <a:extLst>
              <a:ext uri="{FF2B5EF4-FFF2-40B4-BE49-F238E27FC236}">
                <a16:creationId xmlns:a16="http://schemas.microsoft.com/office/drawing/2014/main" id="{680B67AE-158F-6E81-4F1C-B1AF82FF0F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74260" y="2378070"/>
            <a:ext cx="881039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40kDa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4" name="文本框 2">
            <a:extLst>
              <a:ext uri="{FF2B5EF4-FFF2-40B4-BE49-F238E27FC236}">
                <a16:creationId xmlns:a16="http://schemas.microsoft.com/office/drawing/2014/main" id="{6ED1C233-1005-4096-1CD7-2A4DFF7900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74260" y="2083796"/>
            <a:ext cx="881039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50kDa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5" name="文本框 2">
            <a:extLst>
              <a:ext uri="{FF2B5EF4-FFF2-40B4-BE49-F238E27FC236}">
                <a16:creationId xmlns:a16="http://schemas.microsoft.com/office/drawing/2014/main" id="{3DC75FBF-FF2D-3A25-456C-872C18D4D9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74259" y="1893994"/>
            <a:ext cx="881039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70kDa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6" name="文本框 2">
            <a:extLst>
              <a:ext uri="{FF2B5EF4-FFF2-40B4-BE49-F238E27FC236}">
                <a16:creationId xmlns:a16="http://schemas.microsoft.com/office/drawing/2014/main" id="{14CFF5BA-8919-B9AB-DBA6-0059348CBB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93435" y="1638186"/>
            <a:ext cx="881039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0kDa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7" name="文本框 2">
            <a:extLst>
              <a:ext uri="{FF2B5EF4-FFF2-40B4-BE49-F238E27FC236}">
                <a16:creationId xmlns:a16="http://schemas.microsoft.com/office/drawing/2014/main" id="{007CED58-D190-66FA-0DDE-15A48E658A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13281" y="1448384"/>
            <a:ext cx="881039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20kDa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8" name="文本框 2">
            <a:extLst>
              <a:ext uri="{FF2B5EF4-FFF2-40B4-BE49-F238E27FC236}">
                <a16:creationId xmlns:a16="http://schemas.microsoft.com/office/drawing/2014/main" id="{114E1AF9-0331-7633-FCC1-7369AFEB6B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20975" y="839529"/>
            <a:ext cx="1832822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arker:</a:t>
            </a:r>
          </a:p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4-120kDa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F19CCCA4-5CE5-0BAD-8402-8E0016002DED}"/>
              </a:ext>
            </a:extLst>
          </p:cNvPr>
          <p:cNvSpPr/>
          <p:nvPr/>
        </p:nvSpPr>
        <p:spPr>
          <a:xfrm>
            <a:off x="5325374" y="1439135"/>
            <a:ext cx="1357222" cy="2793411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0" name="文本框 2">
            <a:extLst>
              <a:ext uri="{FF2B5EF4-FFF2-40B4-BE49-F238E27FC236}">
                <a16:creationId xmlns:a16="http://schemas.microsoft.com/office/drawing/2014/main" id="{309730C8-704C-8D0B-AAAE-18B3E7DF52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84241" y="1537414"/>
            <a:ext cx="881039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4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L-5</a:t>
            </a:r>
            <a:r>
              <a:rPr lang="en-US" altLang="zh-CN" sz="14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pi</a:t>
            </a:r>
            <a:endParaRPr 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1" name="文本框 2">
            <a:extLst>
              <a:ext uri="{FF2B5EF4-FFF2-40B4-BE49-F238E27FC236}">
                <a16:creationId xmlns:a16="http://schemas.microsoft.com/office/drawing/2014/main" id="{F8111504-7B11-CD99-ED5E-7B340CFEE8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53693" y="1537413"/>
            <a:ext cx="935937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4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L-12</a:t>
            </a:r>
            <a:r>
              <a:rPr lang="en-US" altLang="zh-CN" sz="14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pi</a:t>
            </a:r>
            <a:endParaRPr 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FE94AAD7-6796-37E0-6311-D730E109959E}"/>
              </a:ext>
            </a:extLst>
          </p:cNvPr>
          <p:cNvCxnSpPr/>
          <p:nvPr/>
        </p:nvCxnSpPr>
        <p:spPr>
          <a:xfrm>
            <a:off x="5388634" y="1825167"/>
            <a:ext cx="613403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3F02EF2A-2805-3512-2771-BC491EC614D7}"/>
              </a:ext>
            </a:extLst>
          </p:cNvPr>
          <p:cNvCxnSpPr/>
          <p:nvPr/>
        </p:nvCxnSpPr>
        <p:spPr>
          <a:xfrm>
            <a:off x="6096000" y="1825167"/>
            <a:ext cx="613403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文本框 2">
            <a:extLst>
              <a:ext uri="{FF2B5EF4-FFF2-40B4-BE49-F238E27FC236}">
                <a16:creationId xmlns:a16="http://schemas.microsoft.com/office/drawing/2014/main" id="{2EBEC675-8DA1-A237-07F5-21E632B6DBCF}"/>
              </a:ext>
            </a:extLst>
          </p:cNvPr>
          <p:cNvSpPr txBox="1">
            <a:spLocks noChangeArrowheads="1"/>
          </p:cNvSpPr>
          <p:nvPr/>
        </p:nvSpPr>
        <p:spPr bwMode="auto">
          <a:xfrm rot="18862301">
            <a:off x="5341166" y="1720513"/>
            <a:ext cx="899160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2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326</a:t>
            </a:r>
            <a:endParaRPr 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5" name="文本框 2">
            <a:extLst>
              <a:ext uri="{FF2B5EF4-FFF2-40B4-BE49-F238E27FC236}">
                <a16:creationId xmlns:a16="http://schemas.microsoft.com/office/drawing/2014/main" id="{BECDF005-87F7-F3C0-B2FA-23C6F95AEFDF}"/>
              </a:ext>
            </a:extLst>
          </p:cNvPr>
          <p:cNvSpPr txBox="1">
            <a:spLocks noChangeArrowheads="1"/>
          </p:cNvSpPr>
          <p:nvPr/>
        </p:nvSpPr>
        <p:spPr bwMode="auto">
          <a:xfrm rot="18862301">
            <a:off x="5639421" y="2965377"/>
            <a:ext cx="899160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altLang="zh-CN" sz="1200" kern="100" dirty="0">
                <a:solidFill>
                  <a:srgbClr val="FF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JT88</a:t>
            </a:r>
            <a:endParaRPr 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6" name="文本框 2">
            <a:extLst>
              <a:ext uri="{FF2B5EF4-FFF2-40B4-BE49-F238E27FC236}">
                <a16:creationId xmlns:a16="http://schemas.microsoft.com/office/drawing/2014/main" id="{BB13D435-AE26-C13F-1CE6-A5723B3DDD34}"/>
              </a:ext>
            </a:extLst>
          </p:cNvPr>
          <p:cNvSpPr txBox="1">
            <a:spLocks noChangeArrowheads="1"/>
          </p:cNvSpPr>
          <p:nvPr/>
        </p:nvSpPr>
        <p:spPr bwMode="auto">
          <a:xfrm rot="18862301">
            <a:off x="5953121" y="1694440"/>
            <a:ext cx="899160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2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326</a:t>
            </a:r>
            <a:endParaRPr 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8" name="文本框 2">
            <a:extLst>
              <a:ext uri="{FF2B5EF4-FFF2-40B4-BE49-F238E27FC236}">
                <a16:creationId xmlns:a16="http://schemas.microsoft.com/office/drawing/2014/main" id="{EA514CA9-28F8-F655-49A8-4EA500384C26}"/>
              </a:ext>
            </a:extLst>
          </p:cNvPr>
          <p:cNvSpPr txBox="1">
            <a:spLocks noChangeArrowheads="1"/>
          </p:cNvSpPr>
          <p:nvPr/>
        </p:nvSpPr>
        <p:spPr bwMode="auto">
          <a:xfrm rot="18862301">
            <a:off x="6247212" y="1678411"/>
            <a:ext cx="899160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altLang="zh-CN" sz="1200" kern="100" dirty="0">
                <a:solidFill>
                  <a:srgbClr val="FF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JT88</a:t>
            </a:r>
            <a:endParaRPr 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3" name="文本框 2">
            <a:extLst>
              <a:ext uri="{FF2B5EF4-FFF2-40B4-BE49-F238E27FC236}">
                <a16:creationId xmlns:a16="http://schemas.microsoft.com/office/drawing/2014/main" id="{B9E97FD8-F7CA-49AF-40CD-86A779090D95}"/>
              </a:ext>
            </a:extLst>
          </p:cNvPr>
          <p:cNvSpPr txBox="1">
            <a:spLocks noChangeArrowheads="1"/>
          </p:cNvSpPr>
          <p:nvPr/>
        </p:nvSpPr>
        <p:spPr bwMode="auto">
          <a:xfrm rot="18862301">
            <a:off x="5298875" y="2965378"/>
            <a:ext cx="899160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2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326</a:t>
            </a:r>
            <a:endParaRPr 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4" name="文本框 2">
            <a:extLst>
              <a:ext uri="{FF2B5EF4-FFF2-40B4-BE49-F238E27FC236}">
                <a16:creationId xmlns:a16="http://schemas.microsoft.com/office/drawing/2014/main" id="{904CD77E-A4EA-7DA6-076C-0A4870FE4790}"/>
              </a:ext>
            </a:extLst>
          </p:cNvPr>
          <p:cNvSpPr txBox="1">
            <a:spLocks noChangeArrowheads="1"/>
          </p:cNvSpPr>
          <p:nvPr/>
        </p:nvSpPr>
        <p:spPr bwMode="auto">
          <a:xfrm rot="18862301">
            <a:off x="5626729" y="1678412"/>
            <a:ext cx="899160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altLang="zh-CN" sz="1200" kern="100" dirty="0">
                <a:solidFill>
                  <a:srgbClr val="FF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JT88</a:t>
            </a:r>
            <a:endParaRPr 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5" name="文本框 2">
            <a:extLst>
              <a:ext uri="{FF2B5EF4-FFF2-40B4-BE49-F238E27FC236}">
                <a16:creationId xmlns:a16="http://schemas.microsoft.com/office/drawing/2014/main" id="{DBBFF188-AB7A-EEA2-DCE0-E858E285BF5D}"/>
              </a:ext>
            </a:extLst>
          </p:cNvPr>
          <p:cNvSpPr txBox="1">
            <a:spLocks noChangeArrowheads="1"/>
          </p:cNvSpPr>
          <p:nvPr/>
        </p:nvSpPr>
        <p:spPr bwMode="auto">
          <a:xfrm rot="18862301">
            <a:off x="5972612" y="2949350"/>
            <a:ext cx="899160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2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326</a:t>
            </a:r>
            <a:endParaRPr 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6" name="文本框 2">
            <a:extLst>
              <a:ext uri="{FF2B5EF4-FFF2-40B4-BE49-F238E27FC236}">
                <a16:creationId xmlns:a16="http://schemas.microsoft.com/office/drawing/2014/main" id="{8A628FEF-40A0-587E-203B-1BD578222C7B}"/>
              </a:ext>
            </a:extLst>
          </p:cNvPr>
          <p:cNvSpPr txBox="1">
            <a:spLocks noChangeArrowheads="1"/>
          </p:cNvSpPr>
          <p:nvPr/>
        </p:nvSpPr>
        <p:spPr bwMode="auto">
          <a:xfrm rot="18862301">
            <a:off x="6273272" y="2985341"/>
            <a:ext cx="899160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altLang="zh-CN" sz="1200" kern="100" dirty="0">
                <a:solidFill>
                  <a:srgbClr val="FF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JT88</a:t>
            </a:r>
            <a:endParaRPr 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7" name="文本框 2">
            <a:extLst>
              <a:ext uri="{FF2B5EF4-FFF2-40B4-BE49-F238E27FC236}">
                <a16:creationId xmlns:a16="http://schemas.microsoft.com/office/drawing/2014/main" id="{272B22A8-DB45-60DA-DB45-5DA67024A1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86915" y="2028604"/>
            <a:ext cx="1018924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β-ACTIN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8" name="文本框 2">
            <a:extLst>
              <a:ext uri="{FF2B5EF4-FFF2-40B4-BE49-F238E27FC236}">
                <a16:creationId xmlns:a16="http://schemas.microsoft.com/office/drawing/2014/main" id="{507226FA-3E06-E917-CECE-0923BB4CDD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76677" y="3421477"/>
            <a:ext cx="1018924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MV CP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5584A507-D48F-158B-B6E5-4DBA102F4AA6}"/>
              </a:ext>
            </a:extLst>
          </p:cNvPr>
          <p:cNvSpPr txBox="1"/>
          <p:nvPr/>
        </p:nvSpPr>
        <p:spPr>
          <a:xfrm>
            <a:off x="1639018" y="4814350"/>
            <a:ext cx="7758023" cy="6771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762000" algn="ctr"/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lang="en-US" altLang="zh-CN" sz="20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1d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: The original figure of WB analysis (AL). The purpose bands were highlighted in red frame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80107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CAF1D40D-32C4-A0A3-A70F-9327E50580F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01" t="25675" r="18876" b="53592"/>
          <a:stretch/>
        </p:blipFill>
        <p:spPr bwMode="auto">
          <a:xfrm>
            <a:off x="2345329" y="557842"/>
            <a:ext cx="6749069" cy="1653522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文本框 2">
            <a:extLst>
              <a:ext uri="{FF2B5EF4-FFF2-40B4-BE49-F238E27FC236}">
                <a16:creationId xmlns:a16="http://schemas.microsoft.com/office/drawing/2014/main" id="{3DA21733-CF9F-7FE7-E5AB-50D1BD6DAA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68862" y="793756"/>
            <a:ext cx="447990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altLang="zh-CN" kern="100" dirty="0">
                <a:solidFill>
                  <a:srgbClr val="FF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7#</a:t>
            </a:r>
            <a:endParaRPr lang="zh-CN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文本框 2">
            <a:extLst>
              <a:ext uri="{FF2B5EF4-FFF2-40B4-BE49-F238E27FC236}">
                <a16:creationId xmlns:a16="http://schemas.microsoft.com/office/drawing/2014/main" id="{D52F2813-E392-8990-096F-4FEEC2D73C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02193" y="979161"/>
            <a:ext cx="987995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60kDa</a:t>
            </a:r>
            <a:endParaRPr 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文本框 2">
            <a:extLst>
              <a:ext uri="{FF2B5EF4-FFF2-40B4-BE49-F238E27FC236}">
                <a16:creationId xmlns:a16="http://schemas.microsoft.com/office/drawing/2014/main" id="{52F42134-73A5-122C-32CE-284498A58E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02195" y="547433"/>
            <a:ext cx="987995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75kDa</a:t>
            </a:r>
            <a:endParaRPr 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" name="文本框 2">
            <a:extLst>
              <a:ext uri="{FF2B5EF4-FFF2-40B4-BE49-F238E27FC236}">
                <a16:creationId xmlns:a16="http://schemas.microsoft.com/office/drawing/2014/main" id="{6C92A0D3-0A51-1877-9E91-6EE6EF770D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02194" y="1391025"/>
            <a:ext cx="987995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45kDa</a:t>
            </a:r>
            <a:endParaRPr 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文本框 2">
            <a:extLst>
              <a:ext uri="{FF2B5EF4-FFF2-40B4-BE49-F238E27FC236}">
                <a16:creationId xmlns:a16="http://schemas.microsoft.com/office/drawing/2014/main" id="{F7C2307C-D644-8585-A0A2-54F50AB086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62496" y="793756"/>
            <a:ext cx="987995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WT</a:t>
            </a:r>
            <a:endParaRPr 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1" name="文本框 2">
            <a:extLst>
              <a:ext uri="{FF2B5EF4-FFF2-40B4-BE49-F238E27FC236}">
                <a16:creationId xmlns:a16="http://schemas.microsoft.com/office/drawing/2014/main" id="{4797745A-CD26-36F6-BEE6-089A2B0407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59986" y="793756"/>
            <a:ext cx="570372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altLang="zh-CN" kern="100" dirty="0">
                <a:solidFill>
                  <a:srgbClr val="FF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3#</a:t>
            </a:r>
            <a:endParaRPr lang="zh-CN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2" name="文本框 2">
            <a:extLst>
              <a:ext uri="{FF2B5EF4-FFF2-40B4-BE49-F238E27FC236}">
                <a16:creationId xmlns:a16="http://schemas.microsoft.com/office/drawing/2014/main" id="{4F709570-2BBE-445F-24FC-FBE87BF179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73291" y="812791"/>
            <a:ext cx="570372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altLang="zh-CN" kern="100" dirty="0">
                <a:solidFill>
                  <a:srgbClr val="FF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20#</a:t>
            </a:r>
            <a:endParaRPr lang="zh-CN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FD294B6D-E53F-3BDF-F874-F879F13D14C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28" t="36170" r="17247" b="40640"/>
          <a:stretch/>
        </p:blipFill>
        <p:spPr bwMode="auto">
          <a:xfrm>
            <a:off x="2345328" y="2310352"/>
            <a:ext cx="6770905" cy="1508274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4" name="文本框 2">
            <a:extLst>
              <a:ext uri="{FF2B5EF4-FFF2-40B4-BE49-F238E27FC236}">
                <a16:creationId xmlns:a16="http://schemas.microsoft.com/office/drawing/2014/main" id="{32D146A4-E619-22A2-C51B-C65339030B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27130" y="2465211"/>
            <a:ext cx="987995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kern="100" dirty="0">
                <a:solidFill>
                  <a:srgbClr val="FF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5kDa</a:t>
            </a:r>
            <a:endParaRPr 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5" name="文本框 2">
            <a:extLst>
              <a:ext uri="{FF2B5EF4-FFF2-40B4-BE49-F238E27FC236}">
                <a16:creationId xmlns:a16="http://schemas.microsoft.com/office/drawing/2014/main" id="{387249B6-D457-F890-5117-3B5DADCC53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27130" y="3141918"/>
            <a:ext cx="987995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5kDa</a:t>
            </a:r>
            <a:endParaRPr 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6" name="文本框 2">
            <a:extLst>
              <a:ext uri="{FF2B5EF4-FFF2-40B4-BE49-F238E27FC236}">
                <a16:creationId xmlns:a16="http://schemas.microsoft.com/office/drawing/2014/main" id="{D98D327C-DA49-D30F-44BE-5A07190887C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89557" y="2421058"/>
            <a:ext cx="987995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WT</a:t>
            </a:r>
            <a:endParaRPr 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7" name="文本框 2">
            <a:extLst>
              <a:ext uri="{FF2B5EF4-FFF2-40B4-BE49-F238E27FC236}">
                <a16:creationId xmlns:a16="http://schemas.microsoft.com/office/drawing/2014/main" id="{003EE6A6-71F4-2FC4-A0F1-2C2FA43098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98284" y="2447278"/>
            <a:ext cx="570372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altLang="zh-CN" kern="100" dirty="0">
                <a:solidFill>
                  <a:srgbClr val="FF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7#</a:t>
            </a:r>
            <a:endParaRPr lang="zh-CN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8" name="文本框 2">
            <a:extLst>
              <a:ext uri="{FF2B5EF4-FFF2-40B4-BE49-F238E27FC236}">
                <a16:creationId xmlns:a16="http://schemas.microsoft.com/office/drawing/2014/main" id="{65657445-2DAD-AA34-30B1-BD70C4ABD4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68656" y="2447278"/>
            <a:ext cx="570372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altLang="zh-CN" kern="100" dirty="0">
                <a:solidFill>
                  <a:srgbClr val="FF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3#</a:t>
            </a:r>
            <a:endParaRPr lang="zh-CN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9" name="文本框 2">
            <a:extLst>
              <a:ext uri="{FF2B5EF4-FFF2-40B4-BE49-F238E27FC236}">
                <a16:creationId xmlns:a16="http://schemas.microsoft.com/office/drawing/2014/main" id="{12A33C96-922D-409E-05A0-81674D4EB96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60121" y="2397928"/>
            <a:ext cx="570372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altLang="zh-CN" kern="100" dirty="0">
                <a:solidFill>
                  <a:srgbClr val="FF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20#</a:t>
            </a:r>
            <a:endParaRPr lang="zh-CN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0" name="文本框 2">
            <a:extLst>
              <a:ext uri="{FF2B5EF4-FFF2-40B4-BE49-F238E27FC236}">
                <a16:creationId xmlns:a16="http://schemas.microsoft.com/office/drawing/2014/main" id="{27D90EAA-A39F-B6D9-BB32-B373EF69C6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48893" y="1033691"/>
            <a:ext cx="1018924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β-ACTIN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1" name="文本框 2">
            <a:extLst>
              <a:ext uri="{FF2B5EF4-FFF2-40B4-BE49-F238E27FC236}">
                <a16:creationId xmlns:a16="http://schemas.microsoft.com/office/drawing/2014/main" id="{E713AB0A-1A73-995B-1C3C-8AFEF7CBDA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44359" y="2623371"/>
            <a:ext cx="1018924" cy="431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MV CP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BB97F04-552E-1402-A3DF-42B364EA9F7F}"/>
              </a:ext>
            </a:extLst>
          </p:cNvPr>
          <p:cNvSpPr txBox="1"/>
          <p:nvPr/>
        </p:nvSpPr>
        <p:spPr>
          <a:xfrm>
            <a:off x="1660016" y="4066659"/>
            <a:ext cx="7758023" cy="6771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762000" algn="ctr"/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lang="en-US" altLang="zh-CN" sz="20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5e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: The original figure of WB analysis. The purpose bands were highlighted in red line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3" name="文本框 2">
            <a:extLst>
              <a:ext uri="{FF2B5EF4-FFF2-40B4-BE49-F238E27FC236}">
                <a16:creationId xmlns:a16="http://schemas.microsoft.com/office/drawing/2014/main" id="{E2224778-1640-CE58-B0E4-0C8635FE63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69835" y="-39628"/>
            <a:ext cx="1832822" cy="332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arker:</a:t>
            </a:r>
          </a:p>
          <a:p>
            <a:pPr algn="just"/>
            <a:r>
              <a:rPr lang="en-US" sz="16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-180kDa</a:t>
            </a:r>
            <a:endParaRPr 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4663F3EE-7F57-CB0E-E091-A86629A58537}"/>
              </a:ext>
            </a:extLst>
          </p:cNvPr>
          <p:cNvCxnSpPr>
            <a:cxnSpLocks/>
          </p:cNvCxnSpPr>
          <p:nvPr/>
        </p:nvCxnSpPr>
        <p:spPr>
          <a:xfrm>
            <a:off x="3535881" y="1449458"/>
            <a:ext cx="1961941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32373A55-6EC8-861F-AA0B-1C64E7AFD932}"/>
              </a:ext>
            </a:extLst>
          </p:cNvPr>
          <p:cNvCxnSpPr>
            <a:cxnSpLocks/>
          </p:cNvCxnSpPr>
          <p:nvPr/>
        </p:nvCxnSpPr>
        <p:spPr>
          <a:xfrm>
            <a:off x="3947074" y="3141918"/>
            <a:ext cx="1961941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540232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组合 15">
            <a:extLst>
              <a:ext uri="{FF2B5EF4-FFF2-40B4-BE49-F238E27FC236}">
                <a16:creationId xmlns:a16="http://schemas.microsoft.com/office/drawing/2014/main" id="{2B2BFABB-A800-8386-B740-C21A4C086504}"/>
              </a:ext>
            </a:extLst>
          </p:cNvPr>
          <p:cNvGrpSpPr/>
          <p:nvPr/>
        </p:nvGrpSpPr>
        <p:grpSpPr>
          <a:xfrm>
            <a:off x="1593491" y="113638"/>
            <a:ext cx="9005018" cy="5954848"/>
            <a:chOff x="2565881" y="-18633"/>
            <a:chExt cx="9005018" cy="5954848"/>
          </a:xfrm>
        </p:grpSpPr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DC994B9C-56DB-AACA-D579-C8E4110FB405}"/>
                </a:ext>
              </a:extLst>
            </p:cNvPr>
            <p:cNvGrpSpPr/>
            <p:nvPr/>
          </p:nvGrpSpPr>
          <p:grpSpPr>
            <a:xfrm>
              <a:off x="2565881" y="-18633"/>
              <a:ext cx="9005018" cy="5954848"/>
              <a:chOff x="2430461" y="627998"/>
              <a:chExt cx="7506897" cy="5630173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D2560A49-088B-9667-E671-3AF500789D8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430461" y="627998"/>
                <a:ext cx="7506897" cy="5630173"/>
              </a:xfrm>
              <a:prstGeom prst="rect">
                <a:avLst/>
              </a:prstGeom>
            </p:spPr>
          </p:pic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9F085478-4EDB-0797-2BA6-627C767A47F2}"/>
                  </a:ext>
                </a:extLst>
              </p:cNvPr>
              <p:cNvSpPr txBox="1"/>
              <p:nvPr/>
            </p:nvSpPr>
            <p:spPr>
              <a:xfrm rot="19527244">
                <a:off x="3920048" y="2206720"/>
                <a:ext cx="18873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L 2000 Plus DNA Marker</a:t>
                </a:r>
                <a:endParaRPr lang="zh-CN" altLang="en-US" sz="12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5" name="组合 14">
              <a:extLst>
                <a:ext uri="{FF2B5EF4-FFF2-40B4-BE49-F238E27FC236}">
                  <a16:creationId xmlns:a16="http://schemas.microsoft.com/office/drawing/2014/main" id="{5CF0B67E-1FD3-4B68-9B00-55DB306CAC15}"/>
                </a:ext>
              </a:extLst>
            </p:cNvPr>
            <p:cNvGrpSpPr/>
            <p:nvPr/>
          </p:nvGrpSpPr>
          <p:grpSpPr>
            <a:xfrm>
              <a:off x="4013843" y="2348007"/>
              <a:ext cx="655949" cy="1073299"/>
              <a:chOff x="3674537" y="2806603"/>
              <a:chExt cx="655949" cy="1073299"/>
            </a:xfrm>
          </p:grpSpPr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983FCAA2-76F0-6176-1DA8-8F81FB8071AF}"/>
                  </a:ext>
                </a:extLst>
              </p:cNvPr>
              <p:cNvSpPr txBox="1"/>
              <p:nvPr/>
            </p:nvSpPr>
            <p:spPr>
              <a:xfrm>
                <a:off x="3674537" y="2806603"/>
                <a:ext cx="63350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,000 bp</a:t>
                </a:r>
                <a:endParaRPr lang="zh-CN" altLang="en-US" sz="10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0827C974-F726-7307-A7CB-1B0710E409B5}"/>
                  </a:ext>
                </a:extLst>
              </p:cNvPr>
              <p:cNvSpPr txBox="1"/>
              <p:nvPr/>
            </p:nvSpPr>
            <p:spPr>
              <a:xfrm>
                <a:off x="3674537" y="2937408"/>
                <a:ext cx="63350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,500 bp</a:t>
                </a:r>
                <a:endParaRPr lang="zh-CN" altLang="en-US" sz="10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7E6BAFF0-CF05-B5C4-1A70-4FA30817695A}"/>
                  </a:ext>
                </a:extLst>
              </p:cNvPr>
              <p:cNvSpPr txBox="1"/>
              <p:nvPr/>
            </p:nvSpPr>
            <p:spPr>
              <a:xfrm>
                <a:off x="3674537" y="3049337"/>
                <a:ext cx="65594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5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,000 bp</a:t>
                </a:r>
                <a:endParaRPr lang="zh-CN" altLang="en-US" sz="105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68D73524-458F-EF8B-7CEE-2C71101A23E3}"/>
                  </a:ext>
                </a:extLst>
              </p:cNvPr>
              <p:cNvSpPr txBox="1"/>
              <p:nvPr/>
            </p:nvSpPr>
            <p:spPr>
              <a:xfrm>
                <a:off x="3727435" y="3150892"/>
                <a:ext cx="554960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5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0 bp</a:t>
                </a:r>
                <a:endParaRPr lang="zh-CN" altLang="en-US" sz="105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FD22A3D4-11CD-237E-8EAE-7CAB4B387413}"/>
                  </a:ext>
                </a:extLst>
              </p:cNvPr>
              <p:cNvSpPr txBox="1"/>
              <p:nvPr/>
            </p:nvSpPr>
            <p:spPr>
              <a:xfrm>
                <a:off x="3727434" y="3262821"/>
                <a:ext cx="554960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5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0 bp</a:t>
                </a:r>
                <a:endParaRPr lang="zh-CN" altLang="en-US" sz="105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12FBE432-DF4B-32E5-93ED-08FFBF99B7D6}"/>
                  </a:ext>
                </a:extLst>
              </p:cNvPr>
              <p:cNvSpPr txBox="1"/>
              <p:nvPr/>
            </p:nvSpPr>
            <p:spPr>
              <a:xfrm>
                <a:off x="3753884" y="3364376"/>
                <a:ext cx="554960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5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0 bp</a:t>
                </a:r>
                <a:endParaRPr lang="zh-CN" altLang="en-US" sz="105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F887CE54-8F14-8FCF-3DFC-7298ED34927C}"/>
                  </a:ext>
                </a:extLst>
              </p:cNvPr>
              <p:cNvSpPr txBox="1"/>
              <p:nvPr/>
            </p:nvSpPr>
            <p:spPr>
              <a:xfrm>
                <a:off x="3727433" y="3625986"/>
                <a:ext cx="554960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5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 bp</a:t>
                </a:r>
                <a:endParaRPr lang="zh-CN" altLang="en-US" sz="105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8" name="文本框 17">
            <a:extLst>
              <a:ext uri="{FF2B5EF4-FFF2-40B4-BE49-F238E27FC236}">
                <a16:creationId xmlns:a16="http://schemas.microsoft.com/office/drawing/2014/main" id="{07D3FAB9-9DB0-E3F5-27F2-C07575383909}"/>
              </a:ext>
            </a:extLst>
          </p:cNvPr>
          <p:cNvSpPr txBox="1"/>
          <p:nvPr/>
        </p:nvSpPr>
        <p:spPr>
          <a:xfrm>
            <a:off x="2641769" y="6166554"/>
            <a:ext cx="7171534" cy="6771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lang="en-US" altLang="zh-CN" sz="20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a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ull-length gel image of Fig S1a. The purpose bands were highlighted in red fram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DDB0AE0A-C1B3-6394-935B-9903911674A0}"/>
              </a:ext>
            </a:extLst>
          </p:cNvPr>
          <p:cNvSpPr/>
          <p:nvPr/>
        </p:nvSpPr>
        <p:spPr>
          <a:xfrm>
            <a:off x="3750300" y="2548045"/>
            <a:ext cx="920151" cy="60384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97800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9C0C1E2-CFC0-4E3E-A53B-CFE94EA2DF9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2092" y="316301"/>
            <a:ext cx="7262676" cy="5426015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71CA9D18-3BA2-2241-2B7C-AA19729B5A39}"/>
              </a:ext>
            </a:extLst>
          </p:cNvPr>
          <p:cNvSpPr txBox="1"/>
          <p:nvPr/>
        </p:nvSpPr>
        <p:spPr>
          <a:xfrm>
            <a:off x="2619773" y="5864591"/>
            <a:ext cx="6787314" cy="6771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lang="en-US" altLang="zh-CN" sz="20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3c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ull-length gel image of Fig S3c. The purpose bands were highlighted in red fram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A280009C-DA7A-CFEF-8E9C-EED3017AAF60}"/>
              </a:ext>
            </a:extLst>
          </p:cNvPr>
          <p:cNvSpPr/>
          <p:nvPr/>
        </p:nvSpPr>
        <p:spPr>
          <a:xfrm>
            <a:off x="2840966" y="1708030"/>
            <a:ext cx="2432649" cy="60384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5837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2</TotalTime>
  <Words>196</Words>
  <Application>Microsoft Office PowerPoint</Application>
  <PresentationFormat>宽屏</PresentationFormat>
  <Paragraphs>74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uebo wang</dc:creator>
  <cp:lastModifiedBy>Administrator</cp:lastModifiedBy>
  <cp:revision>4</cp:revision>
  <dcterms:created xsi:type="dcterms:W3CDTF">2023-09-03T23:14:01Z</dcterms:created>
  <dcterms:modified xsi:type="dcterms:W3CDTF">2023-09-14T12:08:17Z</dcterms:modified>
</cp:coreProperties>
</file>